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2" r:id="rId2"/>
    <p:sldId id="263" r:id="rId3"/>
    <p:sldId id="256" r:id="rId4"/>
    <p:sldId id="258" r:id="rId5"/>
    <p:sldId id="259" r:id="rId6"/>
    <p:sldId id="261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431"/>
    <p:restoredTop sz="94590"/>
  </p:normalViewPr>
  <p:slideViewPr>
    <p:cSldViewPr snapToGrid="0" snapToObjects="1">
      <p:cViewPr varScale="1">
        <p:scale>
          <a:sx n="92" d="100"/>
          <a:sy n="92" d="100"/>
        </p:scale>
        <p:origin x="53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8504869-0906-F84E-B13A-91969C25CC2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863956F-C967-8E47-8399-CA45E5E2750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C09D8AC-1414-AD4D-AFE4-539305D98F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0F47EF-47F4-E945-810C-09E405FBC006}" type="datetimeFigureOut">
              <a:rPr kumimoji="1" lang="zh-CN" altLang="en-US" smtClean="0"/>
              <a:t>2021/10/12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AD8B0E2-81E1-A64F-8392-B4CDF8898A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EB07E05-B56A-7146-A87F-95FAFC3DB5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932FC-1E10-AA40-B8B7-D5A338E9BD2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5240791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D62513E-CC22-7947-A2C2-50CAEECCAA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9F75721-EDA8-344C-817B-6A9760B229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779D48D-B28D-EA4B-85AF-90FCF5A432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0F47EF-47F4-E945-810C-09E405FBC006}" type="datetimeFigureOut">
              <a:rPr kumimoji="1" lang="zh-CN" altLang="en-US" smtClean="0"/>
              <a:t>2021/10/12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9D9D163-2F27-C044-A393-6838695AB5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81E60F0-E70F-F94C-AAEC-FF105C5950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932FC-1E10-AA40-B8B7-D5A338E9BD2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624752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393E9D6E-5735-F843-A7CA-3D6D0506429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4F570BD-48D7-FB41-8167-2677E51408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36562FF-59A2-3446-BE5B-E9ABBD68CC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0F47EF-47F4-E945-810C-09E405FBC006}" type="datetimeFigureOut">
              <a:rPr kumimoji="1" lang="zh-CN" altLang="en-US" smtClean="0"/>
              <a:t>2021/10/12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9168BF5-CFD0-F645-B83C-71F3416346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3022D2E-A24E-A442-970B-73B15FFB77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932FC-1E10-AA40-B8B7-D5A338E9BD2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479624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3C02252-4BAE-7248-8109-55947EE70B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1237842-E2F3-A540-B285-F7161E961E5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E0F4BEB-6AD9-A949-B595-250A07894B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0F47EF-47F4-E945-810C-09E405FBC006}" type="datetimeFigureOut">
              <a:rPr kumimoji="1" lang="zh-CN" altLang="en-US" smtClean="0"/>
              <a:t>2021/10/12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E33B1A1-3621-7C45-A1D9-5AC6700647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243BFD9-272E-7544-BCE3-7267EC2738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932FC-1E10-AA40-B8B7-D5A338E9BD2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511728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7C591DC-0307-2F42-A451-226A5F4D01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E8EBF57-EF47-814B-BB74-ACE7607779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B883C65-5CA5-984F-B433-47019C27A0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0F47EF-47F4-E945-810C-09E405FBC006}" type="datetimeFigureOut">
              <a:rPr kumimoji="1" lang="zh-CN" altLang="en-US" smtClean="0"/>
              <a:t>2021/10/12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1544930-B132-4F43-9B55-D3F68E6429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CE6E2A9-FA66-3442-8DF5-6A7972AA99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932FC-1E10-AA40-B8B7-D5A338E9BD2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836806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95ABD44-C1E8-154A-B567-A05B138974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AFC9548-6434-9042-9C06-63DBEA30FB3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3D6E13F-1A03-E948-A87C-D4481076CF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6DA0777-A5F8-DC4A-A280-728002FC98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0F47EF-47F4-E945-810C-09E405FBC006}" type="datetimeFigureOut">
              <a:rPr kumimoji="1" lang="zh-CN" altLang="en-US" smtClean="0"/>
              <a:t>2021/10/12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76D9C10-B4EF-3045-AD4A-EE3125AC9B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9309AA0-1AE3-794B-AE77-B38AB5B1BC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932FC-1E10-AA40-B8B7-D5A338E9BD2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769948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DA97063-0CCF-8A49-AD71-88CBC12F2A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E85AC7C-8980-7E40-889C-5C33A0F8EC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15C180D-384F-B643-8FB0-A0EA20ABAC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7F085AF-D265-2147-92AB-7D7EF77501A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B5A655DB-8F09-3C4B-AC63-B0B6D68D6CE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C5A198E-F379-FB41-9408-FC99FBB158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0F47EF-47F4-E945-810C-09E405FBC006}" type="datetimeFigureOut">
              <a:rPr kumimoji="1" lang="zh-CN" altLang="en-US" smtClean="0"/>
              <a:t>2021/10/12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A1E62DF8-55CB-004B-9A9A-49573EB1D7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2977621-1429-0040-B904-DB82C3DAB7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932FC-1E10-AA40-B8B7-D5A338E9BD2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771594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223766A-DEE4-594C-9B74-88F197CF3C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00167D9-E5DF-224D-833A-B1E3FAA4ED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0F47EF-47F4-E945-810C-09E405FBC006}" type="datetimeFigureOut">
              <a:rPr kumimoji="1" lang="zh-CN" altLang="en-US" smtClean="0"/>
              <a:t>2021/10/12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79E9853-976E-5742-8AB6-BB3FB1F407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97E75DC-F756-CE48-A131-6B0A77CDA7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932FC-1E10-AA40-B8B7-D5A338E9BD2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13797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C2DB05EA-C643-0747-85D0-AE994206AE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0F47EF-47F4-E945-810C-09E405FBC006}" type="datetimeFigureOut">
              <a:rPr kumimoji="1" lang="zh-CN" altLang="en-US" smtClean="0"/>
              <a:t>2021/10/12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D69F302-8F09-E544-B5D6-D91B270CEB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A288392C-4371-4B40-8737-FB7E538C33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932FC-1E10-AA40-B8B7-D5A338E9BD2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048038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A842924-0083-2145-9F6B-22FBC3656A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E398164-B85F-8941-A85E-8BC0E251513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C4A678B-6F39-4D46-A5E1-1F55D2A724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9E690A3-BC66-8749-850D-5BC50934E1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0F47EF-47F4-E945-810C-09E405FBC006}" type="datetimeFigureOut">
              <a:rPr kumimoji="1" lang="zh-CN" altLang="en-US" smtClean="0"/>
              <a:t>2021/10/12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A0F76A9-5208-224A-A119-7BCF503764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501801D-9841-6740-87E1-271C6D550A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932FC-1E10-AA40-B8B7-D5A338E9BD2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557993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FC3F419-A0C9-4C4A-9C30-1B1DCC1557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55E4AF04-F27F-464B-AE04-6D00FA63E0A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E59629E-3DE7-3942-9704-ED6FD6E23E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7A7FB02-4241-E343-A4B0-9D505F404B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0F47EF-47F4-E945-810C-09E405FBC006}" type="datetimeFigureOut">
              <a:rPr kumimoji="1" lang="zh-CN" altLang="en-US" smtClean="0"/>
              <a:t>2021/10/12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01F72EF-66C7-0E40-8486-B17B800F1E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988A7CA-C085-E04A-B661-E75A6BED16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8932FC-1E10-AA40-B8B7-D5A338E9BD2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073013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590BFC3-D63D-CA47-8C87-1BBB41FF13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F727248-B9DB-0B46-BBA4-F8D3FB8756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25AB2CE-52C6-B44D-AF37-38585775B54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0F47EF-47F4-E945-810C-09E405FBC006}" type="datetimeFigureOut">
              <a:rPr kumimoji="1" lang="zh-CN" altLang="en-US" smtClean="0"/>
              <a:t>2021/10/12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77CDEE9-266C-0B4B-A027-2FF3B6A6442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29E5B5C-84D3-1F4D-9D04-2721F6FFCCA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8932FC-1E10-AA40-B8B7-D5A338E9BD2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555285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D07C7FF-602B-2344-A19D-48A260A9A743}"/>
              </a:ext>
            </a:extLst>
          </p:cNvPr>
          <p:cNvSpPr txBox="1"/>
          <p:nvPr/>
        </p:nvSpPr>
        <p:spPr>
          <a:xfrm>
            <a:off x="338666" y="235716"/>
            <a:ext cx="48090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diological evaluation</a:t>
            </a:r>
            <a:r>
              <a:rPr lang="zh-CN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5354CAB0-C9A7-1741-B2F8-AFA9364B5ECE}"/>
              </a:ext>
            </a:extLst>
          </p:cNvPr>
          <p:cNvSpPr txBox="1"/>
          <p:nvPr/>
        </p:nvSpPr>
        <p:spPr>
          <a:xfrm>
            <a:off x="338666" y="697381"/>
            <a:ext cx="11514667" cy="64633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</a:t>
            </a:r>
            <a:r>
              <a:rPr lang="en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diological features were </a:t>
            </a: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ependently</a:t>
            </a:r>
            <a:r>
              <a:rPr lang="zh-CN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aluated by reader 1 (X.F. with 7 years’ experience in liver imaging) and reader 2 (Y.L.L. with 8 years’ experience in liver imaging).</a:t>
            </a:r>
            <a:r>
              <a:rPr lang="en" altLang="zh-CN" sz="2400" i="1" dirty="0"/>
              <a:t> </a:t>
            </a:r>
            <a:r>
              <a:rPr lang="en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 there is any controversy, a senior radiologist with</a:t>
            </a:r>
            <a:r>
              <a:rPr lang="zh-CN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r>
              <a:rPr lang="zh-CN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ar’s experience in abdominal imaging</a:t>
            </a:r>
            <a:r>
              <a:rPr lang="zh-CN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ll be consulted. Radiological evaluation items are defined as followed: (1) </a:t>
            </a: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 size, </a:t>
            </a:r>
            <a:r>
              <a:rPr lang="en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sured by the largest diameter of the tumor on the portal phase trans-axial image; (2) </a:t>
            </a: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er cirrhosis, an irregular, nodular or shrunken liver as well as ascites or evidence of portosystemic collaterals in decompensated stage; (3) No. of segments involved</a:t>
            </a:r>
            <a:r>
              <a:rPr lang="zh-CN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ingle, two or more), liver segments were classified </a:t>
            </a:r>
            <a:r>
              <a:rPr lang="en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cording to the Couinaud methods; (4) </a:t>
            </a: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tellite nodules, small nodules </a:t>
            </a:r>
            <a:r>
              <a:rPr lang="en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ttered </a:t>
            </a: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ound the main lesion;</a:t>
            </a:r>
            <a:r>
              <a:rPr lang="zh-CN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5) Lymph node metastasis,</a:t>
            </a:r>
            <a:r>
              <a:rPr lang="en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minimal axial diameter over 10 mm, or nodes show irregular enhancement; </a:t>
            </a:r>
          </a:p>
          <a:p>
            <a:pPr algn="just">
              <a:lnSpc>
                <a:spcPct val="150000"/>
              </a:lnSpc>
            </a:pPr>
            <a:endParaRPr lang="zh-CN" altLang="zh-CN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8696372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D07C7FF-602B-2344-A19D-48A260A9A743}"/>
              </a:ext>
            </a:extLst>
          </p:cNvPr>
          <p:cNvSpPr txBox="1"/>
          <p:nvPr/>
        </p:nvSpPr>
        <p:spPr>
          <a:xfrm>
            <a:off x="338666" y="304989"/>
            <a:ext cx="48090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diological evaluation</a:t>
            </a:r>
            <a:r>
              <a:rPr lang="zh-CN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5354CAB0-C9A7-1741-B2F8-AFA9364B5ECE}"/>
              </a:ext>
            </a:extLst>
          </p:cNvPr>
          <p:cNvSpPr txBox="1"/>
          <p:nvPr/>
        </p:nvSpPr>
        <p:spPr>
          <a:xfrm>
            <a:off x="338666" y="702035"/>
            <a:ext cx="11514667" cy="64633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</a:t>
            </a:r>
            <a:r>
              <a:rPr lang="en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6) </a:t>
            </a: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rahepatic duct dilatation,</a:t>
            </a:r>
            <a:r>
              <a:rPr lang="en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trahepatic duct dilated with low density</a:t>
            </a: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7) Tumor contour</a:t>
            </a:r>
            <a:r>
              <a:rPr lang="en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urry/infiltrative contour, tumor margin presenting as irregular or blurry; well-defined, tumor margin presenting as nodular tumor with smooth border; (8) The enhancement pattern in the hepatic arterial phase (HAP) : (a) arterial hypo-enhancement that demonstrated iso- to hypoattenuation without a hyperattenuation area in the HAP; (b) arterial hypo-enhancement that demonstrated a hyperattenuation area in the tumour peripheral margin, but for which the hyperattenuation area measured &lt; 50% of the lesion volume in the HAP; or (c) arterial hyper-enhancement that demonstrated a hyperattenuation area that was &gt; 50% of the lesion volume in the HAP; (9) Intratumor vascularity, </a:t>
            </a:r>
            <a:r>
              <a:rPr lang="en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 vessels within liver masses; (10) </a:t>
            </a: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patic capsular retraction</a:t>
            </a:r>
            <a:r>
              <a:rPr lang="en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efers to invagination or focal flattening of the typical smooth contour of the liver capsule.</a:t>
            </a:r>
            <a:endParaRPr lang="zh-CN" altLang="zh-CN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773251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BEB0E76F-E251-BB4C-9A36-E8636F9FAAD1}"/>
              </a:ext>
            </a:extLst>
          </p:cNvPr>
          <p:cNvSpPr txBox="1"/>
          <p:nvPr/>
        </p:nvSpPr>
        <p:spPr>
          <a:xfrm>
            <a:off x="389466" y="471243"/>
            <a:ext cx="48090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 image acquisition protocol</a:t>
            </a:r>
            <a:endParaRPr kumimoji="1" lang="zh-CN" altLang="en-US" sz="240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C1BB21DC-C3CE-3D48-A1FF-86EE86F8A910}"/>
              </a:ext>
            </a:extLst>
          </p:cNvPr>
          <p:cNvSpPr txBox="1"/>
          <p:nvPr/>
        </p:nvSpPr>
        <p:spPr>
          <a:xfrm>
            <a:off x="338666" y="994463"/>
            <a:ext cx="11514667" cy="54476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</a:t>
            </a: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 examinations were performed using SOMATOM Perspective (Siemens Healthineers), SOMATOM Definition Flash (Siemens Healthineers), and SOMATOM Definition AS (Siemens Healthineers). The following scanning parameters were used: tube current, 10 to 644 mA; tube voltage, 100 to 130 KV; slice thickness, 5 mm; detector collimation: 8×2.5 mm or 64×0.625mm; field of view, 350×350 mm; matrix, 388×388. For dynamic contrast-enhanced CT imaging, about 1.3 mL/kg of body weight bolus of iodinated contrast material (Iohexol, GE Healthcare, USA) was injected intravenously at a rate of 3.0 mL/s. The arterial phase (AP) and portal venous phase (PP) were acquired at 40 s, 72 s after the start of contrast injection, respectively.</a:t>
            </a:r>
            <a:endParaRPr lang="zh-CN" altLang="zh-CN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9438185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BEB0E76F-E251-BB4C-9A36-E8636F9FAAD1}"/>
              </a:ext>
            </a:extLst>
          </p:cNvPr>
          <p:cNvSpPr txBox="1"/>
          <p:nvPr/>
        </p:nvSpPr>
        <p:spPr>
          <a:xfrm>
            <a:off x="389466" y="471243"/>
            <a:ext cx="868680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meter setting for radiomics features extraction</a:t>
            </a:r>
            <a:r>
              <a:rPr lang="zh-CN" altLang="zh-CN" sz="240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zh-CN" altLang="en-US" sz="2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C1BB21DC-C3CE-3D48-A1FF-86EE86F8A910}"/>
              </a:ext>
            </a:extLst>
          </p:cNvPr>
          <p:cNvSpPr txBox="1"/>
          <p:nvPr/>
        </p:nvSpPr>
        <p:spPr>
          <a:xfrm>
            <a:off x="338666" y="994463"/>
            <a:ext cx="11514667" cy="33499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Since imaging features will be influenced with different voxel sizes, it is necessary to adopt a resampling strategy for computation of radiomics features. The size of all images was resampled to a pixel size of 3×3×3 mm using sitkBSpline interpolation. Voxel intensities were discretized using a bin-width of 25 HU. Radiomics features were extracted from original, Laplacian of Gaussian features (sigma=3.0,4.0,5.0) and wavelet filtered images.</a:t>
            </a:r>
            <a:endParaRPr lang="zh-CN" altLang="zh-CN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505695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BEB0E76F-E251-BB4C-9A36-E8636F9FAAD1}"/>
              </a:ext>
            </a:extLst>
          </p:cNvPr>
          <p:cNvSpPr txBox="1"/>
          <p:nvPr/>
        </p:nvSpPr>
        <p:spPr>
          <a:xfrm>
            <a:off x="338666" y="249570"/>
            <a:ext cx="868680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I segmentation and ICC</a:t>
            </a:r>
            <a:endParaRPr kumimoji="1" lang="zh-CN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C1BB21DC-C3CE-3D48-A1FF-86EE86F8A910}"/>
              </a:ext>
            </a:extLst>
          </p:cNvPr>
          <p:cNvSpPr txBox="1"/>
          <p:nvPr/>
        </p:nvSpPr>
        <p:spPr>
          <a:xfrm>
            <a:off x="338666" y="585655"/>
            <a:ext cx="11514667" cy="56637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</a:t>
            </a:r>
            <a:r>
              <a:rPr lang="en-US" altLang="zh-CN" sz="2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ion of interests (ROIs) of the whole tumor was contoured blindly on arterial and portal venous phase of CT images using ITK-SNAP software by reader 1</a:t>
            </a:r>
            <a:r>
              <a:rPr lang="zh-CN" altLang="en-US" sz="2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X.F. with 7 years’ experience in liver imaging).</a:t>
            </a:r>
            <a:r>
              <a:rPr lang="zh-CN" altLang="en-US" sz="2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en multiple tumors were present, the tumor with the largest diameter was used to analyze. To</a:t>
            </a:r>
            <a:r>
              <a:rPr lang="zh-CN" altLang="en-US" sz="2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rify reproducibility of the radiomics features, we randomly selected 30 CT images and re-delineated by two readers with years of experience in liver imaging. Reader</a:t>
            </a:r>
            <a:r>
              <a:rPr lang="zh-CN" altLang="en-US" sz="2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re-segmented the tumor ROI at an interval of 2 week to estimate the intra-observer agreement. Reader 2 (Y.L.L. with 8 years’ experience in liver imaging) independently performed the segmentation to estimate the inter-observer agreement. Intra- and inter-class correlation coefficients (ICCs) were calculated to evaluate the reliability of the exacted features. Radiomic features with both intra-observer and inter-observer ICC values &gt; 0.8 were considered to denote good agreement and retained for subsequent investigation.</a:t>
            </a:r>
            <a:endParaRPr lang="zh-CN" altLang="zh-CN" sz="2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84541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BEB0E76F-E251-BB4C-9A36-E8636F9FAAD1}"/>
              </a:ext>
            </a:extLst>
          </p:cNvPr>
          <p:cNvSpPr txBox="1"/>
          <p:nvPr/>
        </p:nvSpPr>
        <p:spPr>
          <a:xfrm>
            <a:off x="389466" y="471243"/>
            <a:ext cx="868680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formula of the radiomics signature</a:t>
            </a:r>
            <a:endParaRPr kumimoji="1" lang="zh-CN" altLang="en-US" sz="2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C1BB21DC-C3CE-3D48-A1FF-86EE86F8A910}"/>
                  </a:ext>
                </a:extLst>
              </p:cNvPr>
              <p:cNvSpPr txBox="1"/>
              <p:nvPr/>
            </p:nvSpPr>
            <p:spPr>
              <a:xfrm>
                <a:off x="287867" y="471243"/>
                <a:ext cx="11514667" cy="54725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lang="en-US" altLang="zh-CN" sz="2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en-US" altLang="zh-CN" sz="2400" i="1" dirty="0"/>
              </a:p>
              <a:p>
                <a:pPr>
                  <a:lnSpc>
                    <a:spcPct val="150000"/>
                  </a:lnSpc>
                </a:pPr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GB" altLang="zh-CN" sz="2400" i="1">
                          <a:latin typeface="Cambria Math" panose="02040503050406030204" pitchFamily="18" charset="0"/>
                        </a:rPr>
                        <m:t>𝑅𝑎𝑑𝑖𝑜𝑚𝑖𝑐𝑠</m:t>
                      </m:r>
                      <m:r>
                        <a:rPr lang="en-GB" altLang="zh-CN" sz="2400" i="1">
                          <a:latin typeface="Cambria Math" panose="02040503050406030204" pitchFamily="18" charset="0"/>
                        </a:rPr>
                        <m:t> </m:t>
                      </m:r>
                      <m:r>
                        <a:rPr lang="en-GB" altLang="zh-CN" sz="2400" i="1">
                          <a:latin typeface="Cambria Math" panose="02040503050406030204" pitchFamily="18" charset="0"/>
                        </a:rPr>
                        <m:t>𝑠𝑐𝑜𝑟𝑒</m:t>
                      </m:r>
                      <m:r>
                        <a:rPr lang="en-GB" altLang="zh-CN" sz="2400">
                          <a:latin typeface="Cambria Math" panose="02040503050406030204" pitchFamily="18" charset="0"/>
                        </a:rPr>
                        <m:t>=</m:t>
                      </m:r>
                      <m:r>
                        <a:rPr lang="en-GB" altLang="zh-CN" sz="2400" i="1">
                          <a:latin typeface="Cambria Math" panose="02040503050406030204" pitchFamily="18" charset="0"/>
                        </a:rPr>
                        <m:t>−</m:t>
                      </m:r>
                      <m:r>
                        <a:rPr lang="en-GB" altLang="zh-CN" sz="2400">
                          <a:latin typeface="Cambria Math" panose="02040503050406030204" pitchFamily="18" charset="0"/>
                        </a:rPr>
                        <m:t>1×</m:t>
                      </m:r>
                      <m:r>
                        <a:rPr lang="en-GB" altLang="zh-CN" sz="2400" i="1">
                          <a:latin typeface="Cambria Math" panose="02040503050406030204" pitchFamily="18" charset="0"/>
                        </a:rPr>
                        <m:t>𝑏</m:t>
                      </m:r>
                      <m:r>
                        <a:rPr lang="en-GB" altLang="zh-CN" sz="2400">
                          <a:latin typeface="Cambria Math" panose="02040503050406030204" pitchFamily="18" charset="0"/>
                        </a:rPr>
                        <m:t>+</m:t>
                      </m:r>
                      <m:nary>
                        <m:naryPr>
                          <m:chr m:val="∑"/>
                          <m:limLoc m:val="undOvr"/>
                          <m:ctrlPr>
                            <a:rPr lang="zh-CN" altLang="zh-CN" sz="2400" i="1">
                              <a:latin typeface="Cambria Math" panose="02040503050406030204" pitchFamily="18" charset="0"/>
                            </a:rPr>
                          </m:ctrlPr>
                        </m:naryPr>
                        <m:sub>
                          <m:r>
                            <a:rPr lang="en-GB" altLang="zh-CN" sz="2400" i="1">
                              <a:latin typeface="Cambria Math" panose="02040503050406030204" pitchFamily="18" charset="0"/>
                            </a:rPr>
                            <m:t>𝑖</m:t>
                          </m:r>
                          <m:r>
                            <a:rPr lang="en-GB" altLang="zh-CN" sz="2400" i="1">
                              <a:latin typeface="Cambria Math" panose="02040503050406030204" pitchFamily="18" charset="0"/>
                            </a:rPr>
                            <m:t>=1</m:t>
                          </m:r>
                        </m:sub>
                        <m:sup>
                          <m:r>
                            <a:rPr lang="en-GB" altLang="zh-CN" sz="2400" i="1">
                              <a:latin typeface="Cambria Math" panose="02040503050406030204" pitchFamily="18" charset="0"/>
                            </a:rPr>
                            <m:t>𝑁</m:t>
                          </m:r>
                        </m:sup>
                        <m:e>
                          <m:r>
                            <a:rPr lang="en-GB" altLang="zh-CN" sz="2400" i="1">
                              <a:latin typeface="Cambria Math" panose="02040503050406030204" pitchFamily="18" charset="0"/>
                            </a:rPr>
                            <m:t>(</m:t>
                          </m:r>
                          <m:sSub>
                            <m:sSubPr>
                              <m:ctrlPr>
                                <a:rPr lang="zh-CN" altLang="zh-CN" sz="2400" b="1" i="1"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r>
                                <a:rPr lang="en-GB" altLang="zh-CN" sz="2400" b="1" i="1">
                                  <a:latin typeface="Cambria Math" panose="02040503050406030204" pitchFamily="18" charset="0"/>
                                </a:rPr>
                                <m:t>𝒔𝒗</m:t>
                              </m:r>
                            </m:e>
                            <m:sub>
                              <m:r>
                                <a:rPr lang="en-GB" altLang="zh-CN" sz="2400" b="1" i="1">
                                  <a:latin typeface="Cambria Math" panose="02040503050406030204" pitchFamily="18" charset="0"/>
                                </a:rPr>
                                <m:t>𝒊</m:t>
                              </m:r>
                            </m:sub>
                          </m:sSub>
                          <m:r>
                            <a:rPr lang="en-GB" altLang="zh-CN" sz="2400" b="1" i="1">
                              <a:latin typeface="Cambria Math" panose="02040503050406030204" pitchFamily="18" charset="0"/>
                            </a:rPr>
                            <m:t>∙</m:t>
                          </m:r>
                          <m:r>
                            <a:rPr lang="en-GB" altLang="zh-CN" sz="2400" b="1" i="1">
                              <a:latin typeface="Cambria Math" panose="02040503050406030204" pitchFamily="18" charset="0"/>
                            </a:rPr>
                            <m:t>𝒙</m:t>
                          </m:r>
                          <m:r>
                            <a:rPr lang="en-GB" altLang="zh-CN" sz="2400" i="1">
                              <a:latin typeface="Cambria Math" panose="02040503050406030204" pitchFamily="18" charset="0"/>
                            </a:rPr>
                            <m:t>)</m:t>
                          </m:r>
                        </m:e>
                      </m:nary>
                    </m:oMath>
                  </m:oMathPara>
                </a14:m>
                <a:endParaRPr lang="en-US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lnSpc>
                    <a:spcPct val="150000"/>
                  </a:lnSpc>
                </a:pPr>
                <a:r>
                  <a:rPr lang="en-GB" altLang="zh-CN" sz="2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here </a:t>
                </a:r>
                <a:endParaRPr lang="zh-CN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lnSpc>
                    <a:spcPct val="150000"/>
                  </a:lnSpc>
                </a:pPr>
                <a14:m>
                  <m:oMath xmlns:m="http://schemas.openxmlformats.org/officeDocument/2006/math">
                    <m:r>
                      <a:rPr lang="en-US" altLang="zh-CN" sz="2400" b="0" i="1" smtClean="0">
                        <a:latin typeface="Cambria Math" panose="02040503050406030204" pitchFamily="18" charset="0"/>
                      </a:rPr>
                      <m:t>            </m:t>
                    </m:r>
                    <m:r>
                      <a:rPr lang="en-GB" altLang="zh-CN" sz="2400" i="1">
                        <a:latin typeface="Cambria Math" panose="02040503050406030204" pitchFamily="18" charset="0"/>
                      </a:rPr>
                      <m:t>𝑏</m:t>
                    </m:r>
                  </m:oMath>
                </a14:m>
                <a:r>
                  <a:rPr lang="en-GB" altLang="zh-CN" sz="2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being the intercept,</a:t>
                </a:r>
                <a:endParaRPr lang="zh-CN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lnSpc>
                    <a:spcPct val="150000"/>
                  </a:lnSpc>
                </a:pPr>
                <a14:m>
                  <m:oMath xmlns:m="http://schemas.openxmlformats.org/officeDocument/2006/math">
                    <m:r>
                      <a:rPr lang="en-US" altLang="zh-CN" sz="2400" b="0" i="1" smtClean="0">
                        <a:latin typeface="Cambria Math" panose="02040503050406030204" pitchFamily="18" charset="0"/>
                      </a:rPr>
                      <m:t>            </m:t>
                    </m:r>
                    <m:r>
                      <a:rPr lang="en-GB" altLang="zh-CN" sz="2400" i="1">
                        <a:latin typeface="Cambria Math" panose="02040503050406030204" pitchFamily="18" charset="0"/>
                      </a:rPr>
                      <m:t>𝑁</m:t>
                    </m:r>
                  </m:oMath>
                </a14:m>
                <a:r>
                  <a:rPr lang="en-GB" altLang="zh-CN" sz="2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being the number of support vectors,</a:t>
                </a:r>
                <a:endParaRPr lang="zh-CN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lnSpc>
                    <a:spcPct val="150000"/>
                  </a:lnSpc>
                </a:pPr>
                <a14:m>
                  <m:oMath xmlns:m="http://schemas.openxmlformats.org/officeDocument/2006/math">
                    <m:sSub>
                      <m:sSubPr>
                        <m:ctrlPr>
                          <a:rPr lang="zh-CN" altLang="zh-CN" sz="2400" b="1" i="1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altLang="zh-CN" sz="2400" b="1" i="1" smtClean="0">
                            <a:latin typeface="Cambria Math" panose="02040503050406030204" pitchFamily="18" charset="0"/>
                          </a:rPr>
                          <m:t>           </m:t>
                        </m:r>
                        <m:r>
                          <a:rPr lang="en-GB" altLang="zh-CN" sz="2400" b="1" i="1">
                            <a:latin typeface="Cambria Math" panose="02040503050406030204" pitchFamily="18" charset="0"/>
                          </a:rPr>
                          <m:t>𝒔𝒗</m:t>
                        </m:r>
                      </m:e>
                      <m:sub>
                        <m:r>
                          <a:rPr lang="en-GB" altLang="zh-CN" sz="2400" b="1" i="1">
                            <a:latin typeface="Cambria Math" panose="02040503050406030204" pitchFamily="18" charset="0"/>
                          </a:rPr>
                          <m:t>𝒊</m:t>
                        </m:r>
                      </m:sub>
                    </m:sSub>
                  </m:oMath>
                </a14:m>
                <a:r>
                  <a:rPr lang="en-GB" altLang="zh-CN" sz="2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being the </a:t>
                </a:r>
                <a14:m>
                  <m:oMath xmlns:m="http://schemas.openxmlformats.org/officeDocument/2006/math">
                    <m:r>
                      <a:rPr lang="en-GB" altLang="zh-CN" sz="2400" i="1">
                        <a:latin typeface="Cambria Math" panose="02040503050406030204" pitchFamily="18" charset="0"/>
                      </a:rPr>
                      <m:t>𝑖</m:t>
                    </m:r>
                  </m:oMath>
                </a14:m>
                <a:r>
                  <a:rPr lang="en-GB" altLang="zh-CN" sz="24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h</a:t>
                </a:r>
                <a:r>
                  <a:rPr lang="en-GB" altLang="zh-CN" sz="2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support vector,</a:t>
                </a:r>
                <a:endParaRPr lang="zh-CN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lnSpc>
                    <a:spcPct val="150000"/>
                  </a:lnSpc>
                </a:pPr>
                <a14:m>
                  <m:oMath xmlns:m="http://schemas.openxmlformats.org/officeDocument/2006/math">
                    <m:r>
                      <a:rPr lang="en-US" altLang="zh-CN" sz="2400" b="0" i="1" smtClean="0">
                        <a:latin typeface="Cambria Math" panose="02040503050406030204" pitchFamily="18" charset="0"/>
                      </a:rPr>
                      <m:t>           </m:t>
                    </m:r>
                    <m:r>
                      <a:rPr lang="en-GB" altLang="zh-CN" sz="2400" i="1">
                        <a:latin typeface="Cambria Math" panose="02040503050406030204" pitchFamily="18" charset="0"/>
                      </a:rPr>
                      <m:t>𝑥</m:t>
                    </m:r>
                  </m:oMath>
                </a14:m>
                <a:r>
                  <a:rPr lang="en-GB" altLang="zh-CN" sz="2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being the new data consisting of the values of the selected feature.</a:t>
                </a:r>
                <a:endParaRPr lang="zh-CN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just">
                  <a:lnSpc>
                    <a:spcPct val="150000"/>
                  </a:lnSpc>
                </a:pPr>
                <a:endParaRPr lang="zh-CN" altLang="zh-CN" sz="2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mc:Choice>
        <mc:Fallback xmlns=""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C1BB21DC-C3CE-3D48-A1FF-86EE86F8A910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87867" y="471243"/>
                <a:ext cx="11514667" cy="5472588"/>
              </a:xfrm>
              <a:prstGeom prst="rect">
                <a:avLst/>
              </a:prstGeom>
              <a:blipFill>
                <a:blip r:embed="rId2"/>
                <a:stretch>
                  <a:fillRect l="-771" t="-1386"/>
                </a:stretch>
              </a:blipFill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662615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5</TotalTime>
  <Words>817</Words>
  <Application>Microsoft Macintosh PowerPoint</Application>
  <PresentationFormat>宽屏</PresentationFormat>
  <Paragraphs>18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2" baseType="lpstr">
      <vt:lpstr>等线</vt:lpstr>
      <vt:lpstr>等线 Light</vt:lpstr>
      <vt:lpstr>Arial</vt:lpstr>
      <vt:lpstr>Cambria Math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User</dc:creator>
  <cp:lastModifiedBy>Microsoft Office User</cp:lastModifiedBy>
  <cp:revision>48</cp:revision>
  <dcterms:created xsi:type="dcterms:W3CDTF">2021-09-08T03:12:26Z</dcterms:created>
  <dcterms:modified xsi:type="dcterms:W3CDTF">2021-10-13T02:23:54Z</dcterms:modified>
</cp:coreProperties>
</file>